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6858000" cy="719963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68" userDrawn="1">
          <p15:clr>
            <a:srgbClr val="A4A3A4"/>
          </p15:clr>
        </p15:guide>
        <p15:guide id="2" pos="21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268"/>
        <p:guide pos="212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674325" y="960014"/>
            <a:ext cx="5512050" cy="269862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674325" y="3738006"/>
            <a:ext cx="5512050" cy="1545849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25" y="812610"/>
            <a:ext cx="6172200" cy="5756302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25" y="2607911"/>
            <a:ext cx="5512050" cy="1069621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25" y="3738006"/>
            <a:ext cx="5512050" cy="495125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638749"/>
            <a:ext cx="6170175" cy="74079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25" y="1564747"/>
            <a:ext cx="6170175" cy="4996606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25" y="4040372"/>
            <a:ext cx="4369950" cy="805051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25" y="4845423"/>
            <a:ext cx="4369950" cy="910879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638749"/>
            <a:ext cx="6170175" cy="74079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25" y="1576085"/>
            <a:ext cx="2911950" cy="498526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25" y="1576085"/>
            <a:ext cx="2911950" cy="4985268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638749"/>
            <a:ext cx="6170175" cy="74079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25" y="1500494"/>
            <a:ext cx="3005100" cy="40063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25" y="1946484"/>
            <a:ext cx="3005100" cy="461486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1492650"/>
            <a:ext cx="3005100" cy="40063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1946484"/>
            <a:ext cx="3005100" cy="461486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638749"/>
            <a:ext cx="6170175" cy="74079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25" y="1632779"/>
            <a:ext cx="2943606" cy="4837864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00" y="1632779"/>
            <a:ext cx="2940300" cy="4837864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075" y="960014"/>
            <a:ext cx="587250" cy="5280075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0" y="960014"/>
            <a:ext cx="5157675" cy="5280075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25" y="638749"/>
            <a:ext cx="6170175" cy="740798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25" y="1564747"/>
            <a:ext cx="6170175" cy="4996606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0" y="6629385"/>
            <a:ext cx="1518750" cy="3326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6629385"/>
            <a:ext cx="2227500" cy="3326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650" y="6629385"/>
            <a:ext cx="1518750" cy="3326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7" Type="http://schemas.openxmlformats.org/officeDocument/2006/relationships/tags" Target="../tags/tag68.xml"/><Relationship Id="rId6" Type="http://schemas.openxmlformats.org/officeDocument/2006/relationships/tags" Target="../tags/tag67.xml"/><Relationship Id="rId5" Type="http://schemas.openxmlformats.org/officeDocument/2006/relationships/tags" Target="../tags/tag66.xml"/><Relationship Id="rId4" Type="http://schemas.openxmlformats.org/officeDocument/2006/relationships/tags" Target="../tags/tag65.xml"/><Relationship Id="rId3" Type="http://schemas.openxmlformats.org/officeDocument/2006/relationships/tags" Target="../tags/tag64.xml"/><Relationship Id="rId2" Type="http://schemas.openxmlformats.org/officeDocument/2006/relationships/tags" Target="../tags/tag63.xml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S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255" y="327025"/>
            <a:ext cx="6727825" cy="3674110"/>
          </a:xfrm>
          <a:prstGeom prst="rect">
            <a:avLst/>
          </a:prstGeom>
        </p:spPr>
      </p:pic>
      <p:sp>
        <p:nvSpPr>
          <p:cNvPr id="51" name="文本框 50"/>
          <p:cNvSpPr txBox="1"/>
          <p:nvPr/>
        </p:nvSpPr>
        <p:spPr>
          <a:xfrm>
            <a:off x="144780" y="3969385"/>
            <a:ext cx="6454775" cy="1029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15" b="1" dirty="0"/>
              <a:t>Supplementary Figure 2. Levels of NS5 gene expression were determined using qRT-PCR. </a:t>
            </a:r>
            <a:r>
              <a:rPr lang="en-US" altLang="zh-CN" sz="1015" dirty="0"/>
              <a:t>Relative levels of NS5 gene expression in JEV-GFP replicon-transfected and drug-treated cells were normalized to level of internal control GAPDH. The drug-treated cells were compared with DMSO-treated control cells, and significant difference was determined using Student’s t-test. *, </a:t>
            </a:r>
            <a:r>
              <a:rPr lang="en-US" altLang="zh-CN" sz="1015" i="1" dirty="0"/>
              <a:t>p </a:t>
            </a:r>
            <a:r>
              <a:rPr lang="en-US" altLang="zh-CN" sz="1015" dirty="0"/>
              <a:t>&lt; 0.05. **, </a:t>
            </a:r>
            <a:r>
              <a:rPr lang="en-US" altLang="zh-CN" sz="1015" i="1" dirty="0"/>
              <a:t>p</a:t>
            </a:r>
            <a:r>
              <a:rPr lang="en-US" altLang="zh-CN" sz="1015" dirty="0"/>
              <a:t> &lt; 0.01. ***, </a:t>
            </a:r>
            <a:r>
              <a:rPr lang="en-US" altLang="zh-CN" sz="1015" i="1" dirty="0"/>
              <a:t>p</a:t>
            </a:r>
            <a:r>
              <a:rPr lang="en-US" altLang="zh-CN" sz="1015" dirty="0"/>
              <a:t> &lt; 0.001. ns, no significant difference.</a:t>
            </a:r>
            <a:endParaRPr lang="en-US" altLang="zh-CN" sz="1015" dirty="0"/>
          </a:p>
          <a:p>
            <a:r>
              <a:rPr lang="en-US" altLang="zh-CN" sz="1015" dirty="0"/>
              <a:t> </a:t>
            </a:r>
            <a:endParaRPr lang="en-US" altLang="zh-CN" sz="1015" dirty="0"/>
          </a:p>
        </p:txBody>
      </p:sp>
      <p:sp>
        <p:nvSpPr>
          <p:cNvPr id="35" name="矩形 34"/>
          <p:cNvSpPr/>
          <p:nvPr>
            <p:custDataLst>
              <p:tags r:id="rId2"/>
            </p:custDataLst>
          </p:nvPr>
        </p:nvSpPr>
        <p:spPr>
          <a:xfrm rot="2700000">
            <a:off x="1394460" y="2918460"/>
            <a:ext cx="166370" cy="58610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4" name="矩形 23"/>
          <p:cNvSpPr/>
          <p:nvPr>
            <p:custDataLst>
              <p:tags r:id="rId3"/>
            </p:custDataLst>
          </p:nvPr>
        </p:nvSpPr>
        <p:spPr>
          <a:xfrm rot="2700000">
            <a:off x="1708785" y="2915285"/>
            <a:ext cx="160655" cy="59118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" name="矩形 5"/>
          <p:cNvSpPr/>
          <p:nvPr>
            <p:custDataLst>
              <p:tags r:id="rId4"/>
            </p:custDataLst>
          </p:nvPr>
        </p:nvSpPr>
        <p:spPr>
          <a:xfrm rot="2700000">
            <a:off x="2014855" y="2912745"/>
            <a:ext cx="172720" cy="5873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8" name="矩形 7"/>
          <p:cNvSpPr/>
          <p:nvPr>
            <p:custDataLst>
              <p:tags r:id="rId5"/>
            </p:custDataLst>
          </p:nvPr>
        </p:nvSpPr>
        <p:spPr>
          <a:xfrm rot="2700000">
            <a:off x="2588260" y="2912745"/>
            <a:ext cx="172720" cy="5873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矩形 8"/>
          <p:cNvSpPr/>
          <p:nvPr>
            <p:custDataLst>
              <p:tags r:id="rId6"/>
            </p:custDataLst>
          </p:nvPr>
        </p:nvSpPr>
        <p:spPr>
          <a:xfrm rot="2700000">
            <a:off x="2894965" y="2912745"/>
            <a:ext cx="172720" cy="5873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  <p:custDataLst>
      <p:tags r:id="rId7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DIAGRAM_VIRTUALLY_FRAME" val="{&quot;height&quot;:726.9420616589102,&quot;left&quot;:0,&quot;top&quot;:21.8,&quot;width&quot;:522.35}"/>
</p:tagLst>
</file>

<file path=ppt/tags/tag64.xml><?xml version="1.0" encoding="utf-8"?>
<p:tagLst xmlns:p="http://schemas.openxmlformats.org/presentationml/2006/main">
  <p:tag name="KSO_WM_DIAGRAM_VIRTUALLY_FRAME" val="{&quot;height&quot;:726.9420616589102,&quot;left&quot;:0,&quot;top&quot;:21.8,&quot;width&quot;:522.35}"/>
</p:tagLst>
</file>

<file path=ppt/tags/tag65.xml><?xml version="1.0" encoding="utf-8"?>
<p:tagLst xmlns:p="http://schemas.openxmlformats.org/presentationml/2006/main">
  <p:tag name="KSO_WM_DIAGRAM_VIRTUALLY_FRAME" val="{&quot;height&quot;:726.9420616589102,&quot;left&quot;:0,&quot;top&quot;:21.8,&quot;width&quot;:522.35}"/>
</p:tagLst>
</file>

<file path=ppt/tags/tag66.xml><?xml version="1.0" encoding="utf-8"?>
<p:tagLst xmlns:p="http://schemas.openxmlformats.org/presentationml/2006/main">
  <p:tag name="KSO_WM_DIAGRAM_VIRTUALLY_FRAME" val="{&quot;height&quot;:726.9420616589102,&quot;left&quot;:0,&quot;top&quot;:21.8,&quot;width&quot;:522.35}"/>
</p:tagLst>
</file>

<file path=ppt/tags/tag67.xml><?xml version="1.0" encoding="utf-8"?>
<p:tagLst xmlns:p="http://schemas.openxmlformats.org/presentationml/2006/main">
  <p:tag name="KSO_WM_DIAGRAM_VIRTUALLY_FRAME" val="{&quot;height&quot;:726.9420616589102,&quot;left&quot;:0,&quot;top&quot;:21.8,&quot;width&quot;:522.35}"/>
</p:tagLst>
</file>

<file path=ppt/tags/tag68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1</Words>
  <Application>WPS 演示</Application>
  <PresentationFormat>宽屏</PresentationFormat>
  <Paragraphs>3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洋流飘。</cp:lastModifiedBy>
  <cp:revision>155</cp:revision>
  <dcterms:created xsi:type="dcterms:W3CDTF">2019-06-19T02:08:00Z</dcterms:created>
  <dcterms:modified xsi:type="dcterms:W3CDTF">2025-05-13T16:43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784</vt:lpwstr>
  </property>
  <property fmtid="{D5CDD505-2E9C-101B-9397-08002B2CF9AE}" pid="3" name="ICV">
    <vt:lpwstr>FE5E9E3D264F43E1BE29BF1CC4DF3C61_11</vt:lpwstr>
  </property>
</Properties>
</file>